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32404F-C1BD-4872-68EC-468EB34AC4BC}" v="65" dt="2025-09-30T06:24:07.6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4694"/>
  </p:normalViewPr>
  <p:slideViewPr>
    <p:cSldViewPr snapToGrid="0">
      <p:cViewPr varScale="1">
        <p:scale>
          <a:sx n="68" d="100"/>
          <a:sy n="68" d="100"/>
        </p:scale>
        <p:origin x="16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40405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68713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5380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9579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56136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59036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40816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07310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77360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80568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38447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105CCE-00C9-4414-9951-6AC349BF8093}" type="datetimeFigureOut">
              <a:rPr lang="zh-TW" altLang="en-US" smtClean="0"/>
              <a:t>2025/9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ED80C-A24D-4694-BF26-F3D329967D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9676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74C62DE-ACDB-77A8-4C0B-547F04219D68}"/>
              </a:ext>
            </a:extLst>
          </p:cNvPr>
          <p:cNvSpPr txBox="1"/>
          <p:nvPr/>
        </p:nvSpPr>
        <p:spPr>
          <a:xfrm>
            <a:off x="7285799" y="6525954"/>
            <a:ext cx="185820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W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E41CCB7C-659C-811B-92F4-5F4ACCD271C2}"/>
              </a:ext>
            </a:extLst>
          </p:cNvPr>
          <p:cNvSpPr txBox="1"/>
          <p:nvPr/>
        </p:nvSpPr>
        <p:spPr>
          <a:xfrm>
            <a:off x="2120317" y="4060272"/>
            <a:ext cx="5186493" cy="15696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altLang="zh-TW" sz="1200" dirty="0">
                <a:latin typeface="Times New Roman"/>
                <a:ea typeface="新細明體"/>
              </a:rPr>
              <a:t>Expression of </a:t>
            </a:r>
            <a:r>
              <a:rPr lang="en-US" altLang="zh-TW" sz="1200" dirty="0" err="1">
                <a:latin typeface="Times New Roman"/>
                <a:ea typeface="新細明體"/>
              </a:rPr>
              <a:t>pTCY</a:t>
            </a:r>
            <a:r>
              <a:rPr lang="en-US" altLang="zh-TW" sz="1200" dirty="0">
                <a:latin typeface="Times New Roman"/>
                <a:ea typeface="新細明體"/>
              </a:rPr>
              <a:t>-spike DNA in BHK-21 cells confirmed by Western blotting. BHK-21 cells were transfected with the </a:t>
            </a:r>
            <a:r>
              <a:rPr lang="en-US" altLang="zh-TW" sz="1200" dirty="0" err="1">
                <a:latin typeface="Times New Roman"/>
                <a:ea typeface="新細明體"/>
              </a:rPr>
              <a:t>pTCY</a:t>
            </a:r>
            <a:r>
              <a:rPr lang="en-US" altLang="zh-TW" sz="1200" dirty="0">
                <a:latin typeface="Times New Roman"/>
                <a:ea typeface="新細明體"/>
              </a:rPr>
              <a:t>-spike DNA construct, while mock-transfected cells served as a negative control (NC). Cell lysates were collected at 24 and 48 h post-transfection and analyzed by Western blot. Serum from PEDV</a:t>
            </a:r>
            <a:r>
              <a:rPr lang="en-US" altLang="zh-TW" sz="1200" dirty="0">
                <a:latin typeface="標楷體"/>
                <a:ea typeface="新細明體"/>
                <a:cs typeface="Times New Roman"/>
              </a:rPr>
              <a:t> </a:t>
            </a:r>
            <a:r>
              <a:rPr lang="en-US" altLang="zh-TW" sz="1200" dirty="0">
                <a:latin typeface="Times New Roman"/>
                <a:ea typeface="新細明體"/>
              </a:rPr>
              <a:t>convalescent pig (1:500 dilution) was used as the primary antibody, and goat anti-swine IgG-HRP (1:2500 dilution) as the secondary antibody. A specific band corresponding to the spike protein (~153 </a:t>
            </a:r>
            <a:r>
              <a:rPr lang="en-US" altLang="zh-TW" sz="1200" dirty="0" err="1">
                <a:latin typeface="Times New Roman"/>
                <a:ea typeface="新細明體"/>
              </a:rPr>
              <a:t>kDa</a:t>
            </a:r>
            <a:r>
              <a:rPr lang="en-US" altLang="zh-TW" sz="1200" dirty="0">
                <a:latin typeface="Times New Roman"/>
                <a:ea typeface="新細明體"/>
              </a:rPr>
              <a:t>) was detected at both 24 and 48 h post-transfection. M: protein marker.</a:t>
            </a:r>
          </a:p>
        </p:txBody>
      </p:sp>
      <p:pic>
        <p:nvPicPr>
          <p:cNvPr id="9" name="圖片 8" descr="一張含有 螢幕擷取畫面, 黑色, 黑與白, Rectangle 的圖片&#10;&#10;AI 產生的內容可能不正確。">
            <a:extLst>
              <a:ext uri="{FF2B5EF4-FFF2-40B4-BE49-F238E27FC236}">
                <a16:creationId xmlns:a16="http://schemas.microsoft.com/office/drawing/2014/main" id="{FB11732A-7003-7F10-1D6C-154730843C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0797" y="1173203"/>
            <a:ext cx="3932341" cy="25506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981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2</TotalTime>
  <Words>108</Words>
  <Application>Microsoft Office PowerPoint</Application>
  <PresentationFormat>如螢幕大小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標楷體</vt:lpstr>
      <vt:lpstr>Arial</vt:lpstr>
      <vt:lpstr>Calibri</vt:lpstr>
      <vt:lpstr>Calibri Light</vt:lpstr>
      <vt:lpstr>Times New Roman</vt:lpstr>
      <vt:lpstr>Office 2013 - 2022 Theme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33</cp:revision>
  <dcterms:created xsi:type="dcterms:W3CDTF">2025-08-31T00:13:57Z</dcterms:created>
  <dcterms:modified xsi:type="dcterms:W3CDTF">2025-09-30T06:46:00Z</dcterms:modified>
</cp:coreProperties>
</file>